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71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941E-1568-44BE-9875-1FB83EE2DA4E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EE3E-95B7-4561-8F5A-D285CBE918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3074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941E-1568-44BE-9875-1FB83EE2DA4E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EE3E-95B7-4561-8F5A-D285CBE918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437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941E-1568-44BE-9875-1FB83EE2DA4E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EE3E-95B7-4561-8F5A-D285CBE918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36824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941E-1568-44BE-9875-1FB83EE2DA4E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EE3E-95B7-4561-8F5A-D285CBE918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17223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941E-1568-44BE-9875-1FB83EE2DA4E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EE3E-95B7-4561-8F5A-D285CBE918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38121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941E-1568-44BE-9875-1FB83EE2DA4E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EE3E-95B7-4561-8F5A-D285CBE918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86183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941E-1568-44BE-9875-1FB83EE2DA4E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EE3E-95B7-4561-8F5A-D285CBE918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55345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941E-1568-44BE-9875-1FB83EE2DA4E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EE3E-95B7-4561-8F5A-D285CBE918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04219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941E-1568-44BE-9875-1FB83EE2DA4E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EE3E-95B7-4561-8F5A-D285CBE918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54450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941E-1568-44BE-9875-1FB83EE2DA4E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EE3E-95B7-4561-8F5A-D285CBE918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57832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941E-1568-44BE-9875-1FB83EE2DA4E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EE3E-95B7-4561-8F5A-D285CBE918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52719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FB941E-1568-44BE-9875-1FB83EE2DA4E}" type="datetimeFigureOut">
              <a:rPr lang="zh-CN" altLang="en-US" smtClean="0"/>
              <a:t>2020/9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D7EE3E-95B7-4561-8F5A-D285CBE918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27143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对象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66432663"/>
              </p:ext>
            </p:extLst>
          </p:nvPr>
        </p:nvGraphicFramePr>
        <p:xfrm>
          <a:off x="4112669" y="679213"/>
          <a:ext cx="3448050" cy="2813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9" name="Prism 6" r:id="rId3" imgW="3448660" imgH="2813163" progId="Prism6.Document">
                  <p:embed/>
                </p:oleObj>
              </mc:Choice>
              <mc:Fallback>
                <p:oleObj name="Prism 6" r:id="rId3" imgW="3448660" imgH="2813163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112669" y="679213"/>
                        <a:ext cx="3448050" cy="2813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对象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21406301"/>
              </p:ext>
            </p:extLst>
          </p:nvPr>
        </p:nvGraphicFramePr>
        <p:xfrm>
          <a:off x="7892482" y="679213"/>
          <a:ext cx="3338513" cy="29162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0" name="Prism 6" r:id="rId5" imgW="3338818" imgH="2916527" progId="Prism6.Document">
                  <p:embed/>
                </p:oleObj>
              </mc:Choice>
              <mc:Fallback>
                <p:oleObj name="Prism 6" r:id="rId5" imgW="3338818" imgH="2916527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892482" y="679213"/>
                        <a:ext cx="3338513" cy="29162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文本框 1"/>
          <p:cNvSpPr txBox="1"/>
          <p:nvPr/>
        </p:nvSpPr>
        <p:spPr>
          <a:xfrm>
            <a:off x="1282890" y="309881"/>
            <a:ext cx="85980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A                                                               B                                                                   C</a:t>
            </a:r>
            <a:endParaRPr lang="zh-CN" altLang="en-US" b="1" dirty="0"/>
          </a:p>
        </p:txBody>
      </p:sp>
      <p:graphicFrame>
        <p:nvGraphicFramePr>
          <p:cNvPr id="5" name="对象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62957887"/>
              </p:ext>
            </p:extLst>
          </p:nvPr>
        </p:nvGraphicFramePr>
        <p:xfrm>
          <a:off x="553494" y="679213"/>
          <a:ext cx="3559175" cy="2552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1" name="Prism 6" r:id="rId7" imgW="3558501" imgH="2552412" progId="Prism6.Document">
                  <p:embed/>
                </p:oleObj>
              </mc:Choice>
              <mc:Fallback>
                <p:oleObj name="Prism 6" r:id="rId7" imgW="3558501" imgH="255241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53494" y="679213"/>
                        <a:ext cx="3559175" cy="2552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矩形 2"/>
          <p:cNvSpPr/>
          <p:nvPr/>
        </p:nvSpPr>
        <p:spPr>
          <a:xfrm>
            <a:off x="3008929" y="3492263"/>
            <a:ext cx="641714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kern="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S.</a:t>
            </a:r>
            <a:r>
              <a:rPr lang="en-US" altLang="zh-CN" b="1" kern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b="1" kern="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en-US" altLang="zh-CN" b="1" kern="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verexpresion</a:t>
            </a:r>
            <a:r>
              <a:rPr lang="en-US" altLang="zh-CN" b="1" kern="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LAS-2 in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mouse myoblasts (C2C12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333081" y="4273988"/>
            <a:ext cx="8661998" cy="1532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altLang="zh-CN" sz="14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, 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relative mRNA expression of ALAS-2</a:t>
            </a:r>
            <a:endParaRPr lang="zh-CN" altLang="zh-CN" sz="14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, The relative mRNA expression of myod1, </a:t>
            </a:r>
            <a:r>
              <a:rPr lang="en-US" altLang="zh-CN" sz="1400" kern="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ogein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S6K1.</a:t>
            </a:r>
            <a:endParaRPr lang="zh-CN" altLang="zh-CN" sz="14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zh-CN" sz="1400" kern="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,The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relative mRNA expression of </a:t>
            </a:r>
            <a:r>
              <a:rPr lang="en-US" altLang="zh-CN" sz="1400" kern="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trophin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400" kern="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ystrophin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Atrogin-1 and MuRF1.</a:t>
            </a:r>
            <a:endParaRPr lang="zh-CN" altLang="zh-CN" sz="14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66700" algn="just">
              <a:lnSpc>
                <a:spcPct val="200000"/>
              </a:lnSpc>
              <a:spcAft>
                <a:spcPts val="0"/>
              </a:spcAft>
            </a:pP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alues are means ± SD.*P&lt;0.05;**P&lt;0.01;***P&lt;0.001.</a:t>
            </a:r>
            <a:endParaRPr lang="zh-CN" altLang="zh-CN" sz="14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391682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46</TotalTime>
  <Words>61</Words>
  <Application>Microsoft Office PowerPoint</Application>
  <PresentationFormat>宽屏</PresentationFormat>
  <Paragraphs>6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宋体</vt:lpstr>
      <vt:lpstr>Arial</vt:lpstr>
      <vt:lpstr>Calibri</vt:lpstr>
      <vt:lpstr>Calibri Light</vt:lpstr>
      <vt:lpstr>Times New Roman</vt:lpstr>
      <vt:lpstr>Office 主题</vt:lpstr>
      <vt:lpstr>Prism 6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tzj</dc:creator>
  <cp:lastModifiedBy>xtzj</cp:lastModifiedBy>
  <cp:revision>11</cp:revision>
  <dcterms:created xsi:type="dcterms:W3CDTF">2020-09-13T03:10:45Z</dcterms:created>
  <dcterms:modified xsi:type="dcterms:W3CDTF">2020-09-17T02:45:15Z</dcterms:modified>
</cp:coreProperties>
</file>